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jpeg" ContentType="image/jpe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416AA1-D6C5-4AFF-8C96-2D4848564B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BA15AE-231C-4991-B24A-02CA74BB1F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2EC232-941C-411C-A5D7-CC4545F6D91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81E0CC-650E-495A-B402-20670C16AD1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196B17-A8A3-4C1E-9840-B0AA159D84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4A867B-72AF-4C93-9E38-CF7F2E14BA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C87793-A185-4CB9-A339-FB81DA610C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8C3478-D0CC-45E7-B661-70BD3F13A3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527040"/>
            <a:ext cx="5914800" cy="887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44D0E3-5690-43E5-A918-1B968EF583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58E0E9-358A-4A00-94AB-4CE2751B3A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396AA4-4056-4CE2-8AD0-F3EDC64580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B2BD7D-A3EB-42E7-A3D4-6FC9B818CC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FE06782-F3C1-43C2-838C-CA4206616D65}" type="slidenum">
              <a:rPr b="0" lang="zh-CN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jpe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2" descr=""/>
          <p:cNvPicPr/>
          <p:nvPr/>
        </p:nvPicPr>
        <p:blipFill>
          <a:blip r:embed="rId1"/>
          <a:srcRect l="0" t="0" r="37315" b="0"/>
          <a:stretch/>
        </p:blipFill>
        <p:spPr>
          <a:xfrm>
            <a:off x="2610000" y="6016680"/>
            <a:ext cx="1922400" cy="1455840"/>
          </a:xfrm>
          <a:prstGeom prst="rect">
            <a:avLst/>
          </a:prstGeom>
          <a:ln w="0">
            <a:noFill/>
          </a:ln>
        </p:spPr>
      </p:pic>
      <p:sp>
        <p:nvSpPr>
          <p:cNvPr id="42" name="文本框 5"/>
          <p:cNvSpPr/>
          <p:nvPr/>
        </p:nvSpPr>
        <p:spPr>
          <a:xfrm>
            <a:off x="1185840" y="5632560"/>
            <a:ext cx="35514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saL</a:t>
            </a: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（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g</a:t>
            </a: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）              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        100   250   500  10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RNA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abeled (5ng)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        +      +        +      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直角三角形 6"/>
          <p:cNvSpPr/>
          <p:nvPr/>
        </p:nvSpPr>
        <p:spPr>
          <a:xfrm flipH="1">
            <a:off x="2612880" y="4929120"/>
            <a:ext cx="1919520" cy="424080"/>
          </a:xfrm>
          <a:prstGeom prst="rtTriangle">
            <a:avLst/>
          </a:prstGeom>
          <a:solidFill>
            <a:srgbClr val="7030a0"/>
          </a:solidFill>
          <a:ln w="12600">
            <a:solidFill>
              <a:srgbClr val="7030a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图片 14" descr=""/>
          <p:cNvPicPr/>
          <p:nvPr/>
        </p:nvPicPr>
        <p:blipFill>
          <a:blip r:embed="rId2"/>
          <a:stretch/>
        </p:blipFill>
        <p:spPr>
          <a:xfrm>
            <a:off x="2212920" y="2125800"/>
            <a:ext cx="2432160" cy="1903320"/>
          </a:xfrm>
          <a:prstGeom prst="rect">
            <a:avLst/>
          </a:prstGeom>
          <a:ln w="0">
            <a:noFill/>
          </a:ln>
        </p:spPr>
      </p:pic>
      <p:sp>
        <p:nvSpPr>
          <p:cNvPr id="45" name="直角三角形 15"/>
          <p:cNvSpPr/>
          <p:nvPr/>
        </p:nvSpPr>
        <p:spPr>
          <a:xfrm flipH="1">
            <a:off x="2235960" y="804960"/>
            <a:ext cx="1546200" cy="504720"/>
          </a:xfrm>
          <a:prstGeom prst="rtTriangle">
            <a:avLst/>
          </a:prstGeom>
          <a:solidFill>
            <a:srgbClr val="00b050"/>
          </a:solidFill>
          <a:ln w="12600">
            <a:solidFill>
              <a:srgbClr val="00b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文本框 16"/>
          <p:cNvSpPr/>
          <p:nvPr/>
        </p:nvSpPr>
        <p:spPr>
          <a:xfrm>
            <a:off x="1047600" y="1376280"/>
            <a:ext cx="39880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saL</a:t>
            </a: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（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g</a:t>
            </a: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）   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    100  500 1000   0     500  1000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obe(5ng)        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       +      +     +      +     +       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       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文本框 17"/>
          <p:cNvSpPr/>
          <p:nvPr/>
        </p:nvSpPr>
        <p:spPr>
          <a:xfrm>
            <a:off x="3571920" y="1822320"/>
            <a:ext cx="104148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rhlI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labele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直接连接符 18"/>
          <p:cNvSpPr/>
          <p:nvPr/>
        </p:nvSpPr>
        <p:spPr>
          <a:xfrm>
            <a:off x="3571920" y="1835280"/>
            <a:ext cx="1042920" cy="0"/>
          </a:xfrm>
          <a:prstGeom prst="line">
            <a:avLst/>
          </a:prstGeom>
          <a:ln w="28440">
            <a:solidFill>
              <a:srgbClr val="5b9bd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本框 19"/>
          <p:cNvSpPr/>
          <p:nvPr/>
        </p:nvSpPr>
        <p:spPr>
          <a:xfrm>
            <a:off x="2106720" y="1835280"/>
            <a:ext cx="1753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S DNA-labele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直接连接符 20"/>
          <p:cNvSpPr/>
          <p:nvPr/>
        </p:nvSpPr>
        <p:spPr>
          <a:xfrm>
            <a:off x="2205000" y="1816200"/>
            <a:ext cx="1260360" cy="0"/>
          </a:xfrm>
          <a:prstGeom prst="line">
            <a:avLst/>
          </a:prstGeom>
          <a:ln w="28440">
            <a:solidFill>
              <a:srgbClr val="00b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直角三角形 21"/>
          <p:cNvSpPr/>
          <p:nvPr/>
        </p:nvSpPr>
        <p:spPr>
          <a:xfrm flipH="1">
            <a:off x="3948840" y="765000"/>
            <a:ext cx="1336680" cy="505080"/>
          </a:xfrm>
          <a:prstGeom prst="rtTriangle">
            <a:avLst/>
          </a:prstGeom>
          <a:solidFill>
            <a:srgbClr val="0070c0"/>
          </a:solidFill>
          <a:ln w="12600">
            <a:solidFill>
              <a:srgbClr val="0070c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文本框 25"/>
          <p:cNvSpPr/>
          <p:nvPr/>
        </p:nvSpPr>
        <p:spPr>
          <a:xfrm>
            <a:off x="1517760" y="2755800"/>
            <a:ext cx="26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本框 26"/>
          <p:cNvSpPr/>
          <p:nvPr/>
        </p:nvSpPr>
        <p:spPr>
          <a:xfrm>
            <a:off x="1515240" y="6607080"/>
            <a:ext cx="26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文本框 27"/>
          <p:cNvSpPr/>
          <p:nvPr/>
        </p:nvSpPr>
        <p:spPr>
          <a:xfrm>
            <a:off x="596880" y="8070840"/>
            <a:ext cx="566280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RsaL has no binding activity towards the single strand DNA or mRN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 (A)</a:t>
            </a: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MSA</a:t>
            </a: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say detected no binding between RsaL and the 234-bp single strand DNA fragment containing the sequence for the 5’-UTR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hlI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RNA. (B)</a:t>
            </a: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MSA</a:t>
            </a: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say</a:t>
            </a: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tected</a:t>
            </a: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</a:t>
            </a: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inding</a:t>
            </a: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etween</a:t>
            </a: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saL</a:t>
            </a: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d</a:t>
            </a: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234-bp mRNA fragment containing the 5’-UTR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hlI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RNA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文本框 4"/>
          <p:cNvSpPr/>
          <p:nvPr/>
        </p:nvSpPr>
        <p:spPr>
          <a:xfrm>
            <a:off x="488880" y="5210280"/>
            <a:ext cx="59562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S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. Verification of the specificity of in-house generated polyclonal antibodies against RsaL by western blot using RsaL recombinant protein after purification (blot on the left-hand side), and various concentration of recombinant protein, and wild-type PA1201 or </a:t>
            </a:r>
            <a:r>
              <a:rPr b="0" lang="el-GR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Δ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rsaL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 protein extract (blot on the right-hand side)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" name="图片 11" descr=""/>
          <p:cNvPicPr/>
          <p:nvPr/>
        </p:nvPicPr>
        <p:blipFill>
          <a:blip r:embed="rId1"/>
          <a:srcRect l="0" t="8180" r="0" b="14217"/>
          <a:stretch/>
        </p:blipFill>
        <p:spPr>
          <a:xfrm>
            <a:off x="3359160" y="3859200"/>
            <a:ext cx="1798560" cy="344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7" name="文本框 13"/>
          <p:cNvSpPr/>
          <p:nvPr/>
        </p:nvSpPr>
        <p:spPr>
          <a:xfrm>
            <a:off x="3336840" y="3608280"/>
            <a:ext cx="20494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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20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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    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0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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PA1201 </a:t>
            </a:r>
            <a:r>
              <a:rPr b="0" lang="el-G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Δ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sa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文本框 4"/>
          <p:cNvSpPr/>
          <p:nvPr/>
        </p:nvSpPr>
        <p:spPr>
          <a:xfrm>
            <a:off x="3620160" y="3414600"/>
            <a:ext cx="44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sa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直接连接符 12"/>
          <p:cNvSpPr/>
          <p:nvPr/>
        </p:nvSpPr>
        <p:spPr>
          <a:xfrm>
            <a:off x="3467160" y="3643200"/>
            <a:ext cx="7920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0" name="组合 14"/>
          <p:cNvGrpSpPr/>
          <p:nvPr/>
        </p:nvGrpSpPr>
        <p:grpSpPr>
          <a:xfrm>
            <a:off x="2000880" y="3151080"/>
            <a:ext cx="983520" cy="1630440"/>
            <a:chOff x="2000880" y="3151080"/>
            <a:chExt cx="983520" cy="1630440"/>
          </a:xfrm>
        </p:grpSpPr>
        <p:sp>
          <p:nvSpPr>
            <p:cNvPr id="61" name="文本框 5"/>
            <p:cNvSpPr/>
            <p:nvPr/>
          </p:nvSpPr>
          <p:spPr>
            <a:xfrm>
              <a:off x="2004120" y="430560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4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文本框 6"/>
            <p:cNvSpPr/>
            <p:nvPr/>
          </p:nvSpPr>
          <p:spPr>
            <a:xfrm>
              <a:off x="2019240" y="3151080"/>
              <a:ext cx="406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文本框 26"/>
            <p:cNvSpPr/>
            <p:nvPr/>
          </p:nvSpPr>
          <p:spPr>
            <a:xfrm>
              <a:off x="2008800" y="413784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7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文本框 28"/>
            <p:cNvSpPr/>
            <p:nvPr/>
          </p:nvSpPr>
          <p:spPr>
            <a:xfrm>
              <a:off x="2000880" y="398592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2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5" name="图片 19" descr=""/>
            <p:cNvPicPr/>
            <p:nvPr/>
          </p:nvPicPr>
          <p:blipFill>
            <a:blip r:embed="rId2"/>
            <a:stretch/>
          </p:blipFill>
          <p:spPr>
            <a:xfrm>
              <a:off x="2350080" y="3215160"/>
              <a:ext cx="634320" cy="1566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文本框 5"/>
            <p:cNvSpPr/>
            <p:nvPr/>
          </p:nvSpPr>
          <p:spPr>
            <a:xfrm>
              <a:off x="2012040" y="44481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1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67" name="直接箭头连接符 21"/>
            <p:cNvCxnSpPr/>
            <p:nvPr/>
          </p:nvCxnSpPr>
          <p:spPr>
            <a:xfrm flipV="1">
              <a:off x="2255760" y="4107600"/>
              <a:ext cx="148320" cy="108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8" name="直接箭头连接符 22"/>
            <p:cNvCxnSpPr/>
            <p:nvPr/>
          </p:nvCxnSpPr>
          <p:spPr>
            <a:xfrm flipV="1">
              <a:off x="2257200" y="4231440"/>
              <a:ext cx="148320" cy="108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9" name="直接箭头连接符 23"/>
            <p:cNvCxnSpPr/>
            <p:nvPr/>
          </p:nvCxnSpPr>
          <p:spPr>
            <a:xfrm flipV="1">
              <a:off x="2262240" y="4431600"/>
              <a:ext cx="148320" cy="108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70" name="直接箭头连接符 24"/>
            <p:cNvCxnSpPr/>
            <p:nvPr/>
          </p:nvCxnSpPr>
          <p:spPr>
            <a:xfrm flipV="1">
              <a:off x="2262240" y="4544280"/>
              <a:ext cx="148320" cy="108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1848960" y="1387440"/>
            <a:ext cx="2567160" cy="52560"/>
          </a:xfrm>
          <a:prstGeom prst="rect">
            <a:avLst/>
          </a:prstGeom>
          <a:noFill/>
          <a:ln w="0">
            <a:noFill/>
          </a:ln>
        </p:spPr>
        <p:txBody>
          <a:bodyPr tIns="6840" bIns="684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1  </a:t>
            </a: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rains used in this study</a:t>
            </a:r>
            <a:endParaRPr b="0" lang="en-US" sz="1200" spc="-1" strike="noStrike">
              <a:solidFill>
                <a:srgbClr val="000000"/>
              </a:solidFill>
              <a:latin typeface="Calibri Light"/>
            </a:endParaRPr>
          </a:p>
        </p:txBody>
      </p:sp>
      <p:pic>
        <p:nvPicPr>
          <p:cNvPr id="72" name="表格 2" descr=""/>
          <p:cNvPicPr/>
          <p:nvPr/>
        </p:nvPicPr>
        <p:blipFill>
          <a:blip r:embed="rId1"/>
          <a:stretch/>
        </p:blipFill>
        <p:spPr>
          <a:xfrm>
            <a:off x="158760" y="1646280"/>
            <a:ext cx="6613560" cy="7607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3" name=""/>
          <p:cNvGraphicFramePr/>
          <p:nvPr/>
        </p:nvGraphicFramePr>
        <p:xfrm>
          <a:off x="163440" y="2387520"/>
          <a:ext cx="6694560" cy="3375000"/>
        </p:xfrm>
        <a:graphic>
          <a:graphicData uri="http://schemas.openxmlformats.org/drawingml/2006/table">
            <a:tbl>
              <a:tblPr/>
              <a:tblGrid>
                <a:gridCol w="1542960"/>
                <a:gridCol w="4343400"/>
                <a:gridCol w="808200"/>
              </a:tblGrid>
              <a:tr h="202320"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lasmid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levant characteristics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ourc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2320"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K18mobsacB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road-host-range gene replacement vector, </a:t>
                      </a: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acB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,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an</a:t>
                      </a:r>
                      <a:r>
                        <a:rPr b="0" lang="en-US" sz="11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b stock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59200"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K18-</a:t>
                      </a: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zM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K18 containing </a:t>
                      </a: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zM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cluster flanking reg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b stock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9200"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K18-</a:t>
                      </a: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z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K18 containing </a:t>
                      </a: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zS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cluster flanking reg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b stock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2320"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K18-</a:t>
                      </a: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qs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K18 c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ntaining </a:t>
                      </a: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qsR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cluster flanking reg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b stock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2320"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K18-</a:t>
                      </a: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K18 c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ntaining </a:t>
                      </a: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cluster flanking reg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b stock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9200"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K18-</a:t>
                      </a: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T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K18 c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ntaining </a:t>
                      </a: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5’-UTR cluster flanking reg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9200"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K18-CC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K18 c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ntaining RsaL binding site point mutant cluster flanking reg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9200"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T28a-</a:t>
                      </a: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hlI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T28a containing RhlI coding sequenc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his study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9200"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T28a-</a:t>
                      </a: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T28a containing RsaL coding sequenc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b stock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5360"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ni-CTX-P</a:t>
                      </a:r>
                      <a:r>
                        <a:rPr b="0" lang="en-US" sz="11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lacZ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tegration-proficient vector with the promoter region of  </a:t>
                      </a: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, Tet</a:t>
                      </a:r>
                      <a:r>
                        <a:rPr b="0" lang="en-US" sz="11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b stock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5360"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ni-CTX-P</a:t>
                      </a:r>
                      <a:r>
                        <a:rPr b="0" lang="en-US" sz="11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hlI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lacZ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tegration-proficient vector with the promoter region of </a:t>
                      </a: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hlI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, Tet</a:t>
                      </a:r>
                      <a:r>
                        <a:rPr b="0" lang="en-US" sz="11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b stock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5360"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ni-CTX-P</a:t>
                      </a:r>
                      <a:r>
                        <a:rPr b="0" lang="en-US" sz="11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sI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lacZ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tegration-proficient vector with the promoter region of  </a:t>
                      </a: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sI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, Tet</a:t>
                      </a:r>
                      <a:r>
                        <a:rPr b="0" lang="en-US" sz="11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b stock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5360"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ni-CTX-P</a:t>
                      </a:r>
                      <a:r>
                        <a:rPr b="0" lang="en-US" sz="11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hlA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lacZ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tegration-proficient vector with the promoter region of  </a:t>
                      </a: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hlA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, Tet</a:t>
                      </a:r>
                      <a:r>
                        <a:rPr b="0" lang="en-US" sz="11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his study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5360"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ni-CTX-P</a:t>
                      </a:r>
                      <a:r>
                        <a:rPr b="0" lang="en-US" sz="11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sB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lacZ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tegration-proficient vector with the promoter region of  </a:t>
                      </a: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sB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, Tet</a:t>
                      </a:r>
                      <a:r>
                        <a:rPr b="0" lang="en-US" sz="11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4560" rIns="34560" tIns="17280" bIns="1728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his study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4560" marR="34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74" name="文本框 5"/>
          <p:cNvSpPr/>
          <p:nvPr/>
        </p:nvSpPr>
        <p:spPr>
          <a:xfrm>
            <a:off x="1709640" y="2111400"/>
            <a:ext cx="432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2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lasmids used in this stud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246240" y="-52920"/>
            <a:ext cx="5914800" cy="4143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3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imers used in this study</a:t>
            </a:r>
            <a:endParaRPr b="0" lang="en-US" sz="1200" spc="-1" strike="noStrike">
              <a:solidFill>
                <a:srgbClr val="000000"/>
              </a:solidFill>
              <a:latin typeface="Calibri Light"/>
            </a:endParaRPr>
          </a:p>
        </p:txBody>
      </p:sp>
      <p:graphicFrame>
        <p:nvGraphicFramePr>
          <p:cNvPr id="76" name=""/>
          <p:cNvGraphicFramePr/>
          <p:nvPr/>
        </p:nvGraphicFramePr>
        <p:xfrm>
          <a:off x="104760" y="279360"/>
          <a:ext cx="6593040" cy="9412200"/>
        </p:xfrm>
        <a:graphic>
          <a:graphicData uri="http://schemas.openxmlformats.org/drawingml/2006/table">
            <a:tbl>
              <a:tblPr/>
              <a:tblGrid>
                <a:gridCol w="1414440"/>
                <a:gridCol w="5178600"/>
              </a:tblGrid>
              <a:tr h="19836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pplica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ligos and sequence(5’to3’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6920">
                <a:tc rowSpan="4"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zS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dele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2880" rIns="2880" tIns="28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zS-F1: CCCAAGCTTAGCCGCGGCCCATTCCTCTTTTT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880" marR="28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880" rIns="2880" tIns="288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zS-R1:CCGTTCTTCGCCGACTGGACCT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880" marR="28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7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880" rIns="2880" tIns="28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zS -F2: CCAGTCGGCGAAGAACGGGGCGCCGACCAGCACATC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880" marR="28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zS -R2: CGGGATCCCCCCCTTGGCGTCGGCATC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6920">
                <a:tc rowSpan="4"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zM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dele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2880" rIns="2880" tIns="28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zM-F1: CGGGATCCCGGGGTGTTCTGCGGTATTTCTC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880" marR="28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880" rIns="2880" tIns="288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zM-R1: GGCATCCGGGCAGCGCTTCA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880" marR="28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880" rIns="2880" tIns="28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zM -F2: AAGCGCTGCCCGGATGCCGACGGCCGGGTGGTGGTGA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880" marR="28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69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zM -R2: GGAATTCCCTGGCGGTGCTGGAGAA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360">
                <a:tc rowSpan="4"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ele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-F1: CGGGATCCGTTGATGGCGAAACGGCTGAGTTC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-R1: GATGTTTTGGGGCTGTGTTCTCTCGT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 -F2: CAGCCCCAAAACATGGAGAATGGCGAGAACCTGCCCTTC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69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 -R2: CCCAAGCTTGTCCTGCCGACCCTGTGGATG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360">
                <a:tc rowSpan="2"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sI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reporter stra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r>
                        <a:rPr b="0" lang="en-US" sz="11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sI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For: CCCAAGCTTGGCGCCTGCTCTCCGATGGTC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556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r>
                        <a:rPr b="0" lang="en-US" sz="11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sI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Rev: CGGGATCCCTTCTTCATCTTGTTCAGTTCTCCTG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720">
                <a:tc rowSpan="2"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hlI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reporter stra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r>
                        <a:rPr b="0" lang="en-US" sz="11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hlI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For:GGAATTCGAGCTCCGGGGAAATCGCCATCA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r>
                        <a:rPr b="0" lang="en-US" sz="11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hlI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Rev: CGGGATCCTTCCAGCGATTCAGAGAGCAATTCGA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360">
                <a:tc rowSpan="2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hlA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porter stra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r>
                        <a:rPr b="0" lang="en-US" sz="11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hlA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For: CCCAAGCTTTCCGCCAACCCCTCGCTGTT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69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r>
                        <a:rPr b="0" lang="en-US" sz="11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hlA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Rev:CGGGATCCTTCACACCTCCCAAAAATTTTCGAAC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360">
                <a:tc rowSpan="2"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reporter stra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2880" rIns="2880" tIns="288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r>
                        <a:rPr b="0" lang="en-US" sz="11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For:CCCAAGCTTGCATGTAGGGGCCAGTGGTATCGA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880" marR="28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880" rIns="2880" tIns="288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r>
                        <a:rPr b="0" lang="en-US" sz="11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Rev:CGGGATCCGTTTTGGGGCTGTGTTCTCTCGTGT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880" marR="28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6920">
                <a:tc rowSpan="2"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hlI protein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2880" rIns="2880" tIns="288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hlI-For: CGGAATTCCAGCTCGCCATCCGCCTCTCC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880" marR="28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880" rIns="2880" tIns="28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hlI-Rev: CGGGATCCGTTCATCGTGTTCCCCTTAAGGTGGA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880" marR="28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720">
                <a:tc rowSpan="2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 prote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2880" rIns="2880" tIns="28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-F</a:t>
                      </a:r>
                      <a:r>
                        <a:rPr b="0" lang="zh-C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：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GCTTCGCTGCTGCTGTGGATG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880" marR="28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6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880" rIns="2880" tIns="28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-R</a:t>
                      </a:r>
                      <a:r>
                        <a:rPr b="0" lang="zh-C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：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AGAGAACATGCTGAAAACAGAGA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880" marR="28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720">
                <a:tc rowSpan="4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erify promoter reporter  stra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ser-up: CGAGTGGTTTAAGGCAACGGTCTTG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ser-down: AGTTCGGCCTGGTGGAACAACTC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cZ-F</a:t>
                      </a:r>
                      <a:r>
                        <a:rPr b="0" lang="zh-C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：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CTCCGCCGCCTTCATACTG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69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cZ-R</a:t>
                      </a:r>
                      <a:r>
                        <a:rPr b="0" lang="zh-C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：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CGCCGAAATCCCGAATCTC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360">
                <a:tc rowSpan="2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hlI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EMSA prob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Y5P</a:t>
                      </a:r>
                      <a:r>
                        <a:rPr b="0" lang="en-US" sz="11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hlI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F:AGCCAGTGGCGATAAGCCATCATCCTGAGGCATCTCCGAG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Y5P</a:t>
                      </a:r>
                      <a:r>
                        <a:rPr b="0" lang="en-US" sz="11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hlI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R:AGCCAGTGGCGATAAGGACCAAGTCCCCGTGTCGTGC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6920">
                <a:tc rowSpan="3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’RAC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-raceRT: ATCTTGCCTCTCAGGTCGGCGAGCT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-raceR1: ATAGGGAAGGGCAGGTTCTCGCCATT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-raceR2: GAAGCGGCTCCAGAAAGTTTCCTGGC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720">
                <a:tc rowSpan="4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’-UTR dele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elrsaL-F1: CGGAATTCGAACTCTTCGCGCCGACCAATTTGTA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69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elrsaL-R1: TGCTCTGATCTTTTCAATCTATCTCATTTGCTAGTTATAA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elrsaL-F2: GAAAAGATCAGAGCAATGGCTTCACA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elrsaL-R2: CGGGATCCCCATTATGGCCGTTAATTTGGGTCTT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06280">
                <a:tc rowSpan="2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hlI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RsaL binding site point mutan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rb-F: TCATGTGTGTGCTGGCCCGTCCTCCGACTGAG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062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rb-R: TCTCAGTCGGAGGACGGGCCAGCACACACATG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44800">
                <a:tc rowSpan="6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aL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EMSA prob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8160" rIns="38160" tIns="38160" bIns="381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rsaL-HF: AGCCAGTGGCGATAAGGAGATAGATTTCGGTGAACCCGGACC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8160" marR="38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444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8160" rIns="38160" tIns="38160" bIns="381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rsaL-HR: AGCCAGTGGCGATAAGGCTTATCCCGAAGCGGCTCCAGAA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8160" marR="38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6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rsaLQF:  AGCCAGTGGCGATAAGGCGTCATAACCATCGATTTCCATCT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448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8160" rIns="38160" tIns="38160" bIns="381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rsaL-QR: AGCCAGTGGCGATAAGGCTTCCTATTTGGAGGAAGTGAAGATG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8160" marR="38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440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8160" rIns="38160" tIns="38160" bIns="381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BS12-F:</a:t>
                      </a:r>
                      <a:r>
                        <a:rPr b="0" lang="zh-C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CCAGTGGCGATAAGATGCAAATTTCATAATTTTATAACTAGC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8160" marR="38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440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8160" rIns="38160" tIns="38160" bIns="381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BS12-R:</a:t>
                      </a:r>
                      <a:r>
                        <a:rPr b="0" lang="zh-C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CCAGTGGCGATAAGGTCCGGGTTCACCGAAATCTATCTCA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8160" marR="38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6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5-11T01:47:00Z</dcterms:created>
  <dc:creator>Jin Qiyun</dc:creator>
  <dc:description/>
  <dc:language>en-US</dc:language>
  <cp:lastModifiedBy>lenovo</cp:lastModifiedBy>
  <dcterms:modified xsi:type="dcterms:W3CDTF">2023-11-04T14:43:22Z</dcterms:modified>
  <cp:revision>927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952</vt:lpwstr>
  </property>
</Properties>
</file>